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33E086-478D-40A0-AC2F-AD87F2B1E7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80C2D-E724-4DEC-BBE7-24AD500BC4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01649-B31C-4438-856F-52B6A30781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7FCBF-DFB5-41F2-AA47-6B97A3C47F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386A2-C597-44FA-A78A-1776D5AA4A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F668B-DCC6-43DE-8BF6-B450EEB7B6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7AB78-3706-4C8A-B640-DD7D03EBE8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69E4B-1A76-4C00-A970-FF5F6F0216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9B252B-D12E-4831-8CAF-CB34FAD9AA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CC27F-6A2B-460F-A8E4-CA6631D564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2E03A5-BD5F-4CD3-8693-529C45C68C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C04D9-0D89-473B-A24E-D448D29804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5FE105-0232-485D-B183-6ED6C3F0894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149720" y="20541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086360" y="2131920"/>
            <a:ext cx="60120" cy="109800"/>
          </a:xfrm>
          <a:custGeom>
            <a:avLst/>
            <a:gdLst/>
            <a:ahLst/>
            <a:rect l="l" t="t" r="r" b="b"/>
            <a:pathLst>
              <a:path w="38" h="69">
                <a:moveTo>
                  <a:pt x="0" y="69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164480" y="22827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086360" y="2251080"/>
            <a:ext cx="74520" cy="109440"/>
          </a:xfrm>
          <a:custGeom>
            <a:avLst/>
            <a:gdLst/>
            <a:ahLst/>
            <a:rect l="l" t="t" r="r" b="b"/>
            <a:pathLst>
              <a:path w="47" h="69">
                <a:moveTo>
                  <a:pt x="0" y="0"/>
                </a:moveTo>
                <a:lnTo>
                  <a:pt x="0" y="69"/>
                </a:lnTo>
                <a:lnTo>
                  <a:pt x="47" y="6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014720" y="2246400"/>
            <a:ext cx="71640" cy="166680"/>
          </a:xfrm>
          <a:custGeom>
            <a:avLst/>
            <a:gdLst/>
            <a:ahLst/>
            <a:rect l="l" t="t" r="r" b="b"/>
            <a:pathLst>
              <a:path w="45" h="105">
                <a:moveTo>
                  <a:pt x="0" y="105"/>
                </a:moveTo>
                <a:lnTo>
                  <a:pt x="0" y="0"/>
                </a:lnTo>
                <a:lnTo>
                  <a:pt x="45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123080" y="251136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014720" y="2422440"/>
            <a:ext cx="104760" cy="166680"/>
          </a:xfrm>
          <a:custGeom>
            <a:avLst/>
            <a:gdLst/>
            <a:ahLst/>
            <a:rect l="l" t="t" r="r" b="b"/>
            <a:pathLst>
              <a:path w="66" h="105">
                <a:moveTo>
                  <a:pt x="0" y="0"/>
                </a:moveTo>
                <a:lnTo>
                  <a:pt x="0" y="105"/>
                </a:lnTo>
                <a:lnTo>
                  <a:pt x="66" y="105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3710160" y="2417760"/>
            <a:ext cx="304560" cy="195120"/>
          </a:xfrm>
          <a:custGeom>
            <a:avLst/>
            <a:gdLst/>
            <a:ahLst/>
            <a:rect l="l" t="t" r="r" b="b"/>
            <a:pathLst>
              <a:path w="192" h="123">
                <a:moveTo>
                  <a:pt x="0" y="123"/>
                </a:moveTo>
                <a:lnTo>
                  <a:pt x="0" y="0"/>
                </a:lnTo>
                <a:lnTo>
                  <a:pt x="19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028040" y="27399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710160" y="2622600"/>
            <a:ext cx="314280" cy="195120"/>
          </a:xfrm>
          <a:custGeom>
            <a:avLst/>
            <a:gdLst/>
            <a:ahLst/>
            <a:rect l="l" t="t" r="r" b="b"/>
            <a:pathLst>
              <a:path w="198" h="123">
                <a:moveTo>
                  <a:pt x="0" y="0"/>
                </a:moveTo>
                <a:lnTo>
                  <a:pt x="0" y="123"/>
                </a:lnTo>
                <a:lnTo>
                  <a:pt x="198" y="12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3675240" y="2617920"/>
            <a:ext cx="34920" cy="266400"/>
          </a:xfrm>
          <a:custGeom>
            <a:avLst/>
            <a:gdLst/>
            <a:ahLst/>
            <a:rect l="l" t="t" r="r" b="b"/>
            <a:pathLst>
              <a:path w="22" h="168">
                <a:moveTo>
                  <a:pt x="0" y="168"/>
                </a:moveTo>
                <a:lnTo>
                  <a:pt x="0" y="0"/>
                </a:lnTo>
                <a:lnTo>
                  <a:pt x="2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228200" y="29685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909960" y="3046320"/>
            <a:ext cx="314280" cy="109800"/>
          </a:xfrm>
          <a:custGeom>
            <a:avLst/>
            <a:gdLst/>
            <a:ahLst/>
            <a:rect l="l" t="t" r="r" b="b"/>
            <a:pathLst>
              <a:path w="198" h="69">
                <a:moveTo>
                  <a:pt x="0" y="69"/>
                </a:moveTo>
                <a:lnTo>
                  <a:pt x="0" y="0"/>
                </a:lnTo>
                <a:lnTo>
                  <a:pt x="198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459320" y="319716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909960" y="3165480"/>
            <a:ext cx="546120" cy="109440"/>
          </a:xfrm>
          <a:custGeom>
            <a:avLst/>
            <a:gdLst/>
            <a:ahLst/>
            <a:rect l="l" t="t" r="r" b="b"/>
            <a:pathLst>
              <a:path w="344" h="69">
                <a:moveTo>
                  <a:pt x="0" y="0"/>
                </a:moveTo>
                <a:lnTo>
                  <a:pt x="0" y="69"/>
                </a:lnTo>
                <a:lnTo>
                  <a:pt x="344" y="6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675240" y="2894040"/>
            <a:ext cx="234720" cy="266760"/>
          </a:xfrm>
          <a:custGeom>
            <a:avLst/>
            <a:gdLst/>
            <a:ahLst/>
            <a:rect l="l" t="t" r="r" b="b"/>
            <a:pathLst>
              <a:path w="148" h="168">
                <a:moveTo>
                  <a:pt x="0" y="0"/>
                </a:moveTo>
                <a:lnTo>
                  <a:pt x="0" y="168"/>
                </a:lnTo>
                <a:lnTo>
                  <a:pt x="148" y="168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476520" y="2889360"/>
            <a:ext cx="198720" cy="301680"/>
          </a:xfrm>
          <a:custGeom>
            <a:avLst/>
            <a:gdLst/>
            <a:ahLst/>
            <a:rect l="l" t="t" r="r" b="b"/>
            <a:pathLst>
              <a:path w="125" h="190">
                <a:moveTo>
                  <a:pt x="0" y="190"/>
                </a:moveTo>
                <a:lnTo>
                  <a:pt x="0" y="0"/>
                </a:lnTo>
                <a:lnTo>
                  <a:pt x="125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649680" y="34257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476520" y="3200400"/>
            <a:ext cx="169920" cy="303120"/>
          </a:xfrm>
          <a:custGeom>
            <a:avLst/>
            <a:gdLst/>
            <a:ahLst/>
            <a:rect l="l" t="t" r="r" b="b"/>
            <a:pathLst>
              <a:path w="107" h="191">
                <a:moveTo>
                  <a:pt x="0" y="0"/>
                </a:moveTo>
                <a:lnTo>
                  <a:pt x="0" y="191"/>
                </a:lnTo>
                <a:lnTo>
                  <a:pt x="107" y="191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770200" y="3195720"/>
            <a:ext cx="706320" cy="533160"/>
          </a:xfrm>
          <a:custGeom>
            <a:avLst/>
            <a:gdLst/>
            <a:ahLst/>
            <a:rect l="l" t="t" r="r" b="b"/>
            <a:pathLst>
              <a:path w="445" h="336">
                <a:moveTo>
                  <a:pt x="0" y="336"/>
                </a:moveTo>
                <a:lnTo>
                  <a:pt x="0" y="0"/>
                </a:lnTo>
                <a:lnTo>
                  <a:pt x="445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918240" y="365436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557520" y="3732120"/>
            <a:ext cx="357120" cy="109800"/>
          </a:xfrm>
          <a:custGeom>
            <a:avLst/>
            <a:gdLst/>
            <a:ahLst/>
            <a:rect l="l" t="t" r="r" b="b"/>
            <a:pathLst>
              <a:path w="225" h="69">
                <a:moveTo>
                  <a:pt x="0" y="69"/>
                </a:moveTo>
                <a:lnTo>
                  <a:pt x="0" y="0"/>
                </a:lnTo>
                <a:lnTo>
                  <a:pt x="225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935520" y="38829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557520" y="3851280"/>
            <a:ext cx="374760" cy="109440"/>
          </a:xfrm>
          <a:custGeom>
            <a:avLst/>
            <a:gdLst/>
            <a:ahLst/>
            <a:rect l="l" t="t" r="r" b="b"/>
            <a:pathLst>
              <a:path w="236" h="69">
                <a:moveTo>
                  <a:pt x="0" y="0"/>
                </a:moveTo>
                <a:lnTo>
                  <a:pt x="0" y="69"/>
                </a:lnTo>
                <a:lnTo>
                  <a:pt x="236" y="6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381480" y="3846600"/>
            <a:ext cx="176040" cy="166680"/>
          </a:xfrm>
          <a:custGeom>
            <a:avLst/>
            <a:gdLst/>
            <a:ahLst/>
            <a:rect l="l" t="t" r="r" b="b"/>
            <a:pathLst>
              <a:path w="111" h="105">
                <a:moveTo>
                  <a:pt x="0" y="105"/>
                </a:moveTo>
                <a:lnTo>
                  <a:pt x="0" y="0"/>
                </a:lnTo>
                <a:lnTo>
                  <a:pt x="111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080600" y="411156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381480" y="4022640"/>
            <a:ext cx="695160" cy="166680"/>
          </a:xfrm>
          <a:custGeom>
            <a:avLst/>
            <a:gdLst/>
            <a:ahLst/>
            <a:rect l="l" t="t" r="r" b="b"/>
            <a:pathLst>
              <a:path w="438" h="105">
                <a:moveTo>
                  <a:pt x="0" y="0"/>
                </a:moveTo>
                <a:lnTo>
                  <a:pt x="0" y="105"/>
                </a:lnTo>
                <a:lnTo>
                  <a:pt x="438" y="105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193920" y="4017960"/>
            <a:ext cx="187560" cy="252360"/>
          </a:xfrm>
          <a:custGeom>
            <a:avLst/>
            <a:gdLst/>
            <a:ahLst/>
            <a:rect l="l" t="t" r="r" b="b"/>
            <a:pathLst>
              <a:path w="118" h="159">
                <a:moveTo>
                  <a:pt x="0" y="159"/>
                </a:moveTo>
                <a:lnTo>
                  <a:pt x="0" y="0"/>
                </a:lnTo>
                <a:lnTo>
                  <a:pt x="118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616560" y="43401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570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300480" y="4417920"/>
            <a:ext cx="312840" cy="109800"/>
          </a:xfrm>
          <a:custGeom>
            <a:avLst/>
            <a:gdLst/>
            <a:ahLst/>
            <a:rect l="l" t="t" r="r" b="b"/>
            <a:pathLst>
              <a:path w="197" h="69">
                <a:moveTo>
                  <a:pt x="0" y="69"/>
                </a:moveTo>
                <a:lnTo>
                  <a:pt x="0" y="0"/>
                </a:lnTo>
                <a:lnTo>
                  <a:pt x="19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932640" y="456876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300480" y="4537080"/>
            <a:ext cx="628560" cy="109440"/>
          </a:xfrm>
          <a:custGeom>
            <a:avLst/>
            <a:gdLst/>
            <a:ahLst/>
            <a:rect l="l" t="t" r="r" b="b"/>
            <a:pathLst>
              <a:path w="396" h="69">
                <a:moveTo>
                  <a:pt x="0" y="0"/>
                </a:moveTo>
                <a:lnTo>
                  <a:pt x="0" y="69"/>
                </a:lnTo>
                <a:lnTo>
                  <a:pt x="396" y="6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193920" y="4280040"/>
            <a:ext cx="106560" cy="252360"/>
          </a:xfrm>
          <a:custGeom>
            <a:avLst/>
            <a:gdLst/>
            <a:ahLst/>
            <a:rect l="l" t="t" r="r" b="b"/>
            <a:pathLst>
              <a:path w="67" h="159">
                <a:moveTo>
                  <a:pt x="0" y="0"/>
                </a:moveTo>
                <a:lnTo>
                  <a:pt x="0" y="159"/>
                </a:lnTo>
                <a:lnTo>
                  <a:pt x="67" y="15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770200" y="3738600"/>
            <a:ext cx="423720" cy="536400"/>
          </a:xfrm>
          <a:custGeom>
            <a:avLst/>
            <a:gdLst/>
            <a:ahLst/>
            <a:rect l="l" t="t" r="r" b="b"/>
            <a:pathLst>
              <a:path w="267" h="338">
                <a:moveTo>
                  <a:pt x="0" y="0"/>
                </a:moveTo>
                <a:lnTo>
                  <a:pt x="0" y="338"/>
                </a:lnTo>
                <a:lnTo>
                  <a:pt x="267" y="338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704960" y="3733920"/>
            <a:ext cx="1065240" cy="1355760"/>
          </a:xfrm>
          <a:custGeom>
            <a:avLst/>
            <a:gdLst/>
            <a:ahLst/>
            <a:rect l="l" t="t" r="r" b="b"/>
            <a:pathLst>
              <a:path w="671" h="854">
                <a:moveTo>
                  <a:pt x="0" y="854"/>
                </a:moveTo>
                <a:lnTo>
                  <a:pt x="0" y="0"/>
                </a:lnTo>
                <a:lnTo>
                  <a:pt x="671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404240" y="47973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9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381560" y="4875120"/>
            <a:ext cx="19080" cy="109800"/>
          </a:xfrm>
          <a:custGeom>
            <a:avLst/>
            <a:gdLst/>
            <a:ahLst/>
            <a:rect l="l" t="t" r="r" b="b"/>
            <a:pathLst>
              <a:path w="12" h="69">
                <a:moveTo>
                  <a:pt x="0" y="69"/>
                </a:moveTo>
                <a:lnTo>
                  <a:pt x="0" y="0"/>
                </a:lnTo>
                <a:lnTo>
                  <a:pt x="12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459320" y="5025960"/>
            <a:ext cx="3650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1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381560" y="4994280"/>
            <a:ext cx="74520" cy="109440"/>
          </a:xfrm>
          <a:custGeom>
            <a:avLst/>
            <a:gdLst/>
            <a:ahLst/>
            <a:rect l="l" t="t" r="r" b="b"/>
            <a:pathLst>
              <a:path w="47" h="69">
                <a:moveTo>
                  <a:pt x="0" y="0"/>
                </a:moveTo>
                <a:lnTo>
                  <a:pt x="0" y="69"/>
                </a:lnTo>
                <a:lnTo>
                  <a:pt x="47" y="6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038480" y="4989600"/>
            <a:ext cx="343080" cy="166680"/>
          </a:xfrm>
          <a:custGeom>
            <a:avLst/>
            <a:gdLst/>
            <a:ahLst/>
            <a:rect l="l" t="t" r="r" b="b"/>
            <a:pathLst>
              <a:path w="216" h="105">
                <a:moveTo>
                  <a:pt x="0" y="105"/>
                </a:moveTo>
                <a:lnTo>
                  <a:pt x="0" y="0"/>
                </a:lnTo>
                <a:lnTo>
                  <a:pt x="216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327920" y="5254560"/>
            <a:ext cx="4471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S991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4038480" y="5165640"/>
            <a:ext cx="285840" cy="166680"/>
          </a:xfrm>
          <a:custGeom>
            <a:avLst/>
            <a:gdLst/>
            <a:ahLst/>
            <a:rect l="l" t="t" r="r" b="b"/>
            <a:pathLst>
              <a:path w="180" h="105">
                <a:moveTo>
                  <a:pt x="0" y="0"/>
                </a:moveTo>
                <a:lnTo>
                  <a:pt x="0" y="105"/>
                </a:lnTo>
                <a:lnTo>
                  <a:pt x="180" y="105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970440" y="5160960"/>
            <a:ext cx="68040" cy="195120"/>
          </a:xfrm>
          <a:custGeom>
            <a:avLst/>
            <a:gdLst/>
            <a:ahLst/>
            <a:rect l="l" t="t" r="r" b="b"/>
            <a:pathLst>
              <a:path w="43" h="123">
                <a:moveTo>
                  <a:pt x="0" y="123"/>
                </a:moveTo>
                <a:lnTo>
                  <a:pt x="0" y="0"/>
                </a:lnTo>
                <a:lnTo>
                  <a:pt x="43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455000" y="54831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31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970440" y="5365800"/>
            <a:ext cx="480960" cy="195120"/>
          </a:xfrm>
          <a:custGeom>
            <a:avLst/>
            <a:gdLst/>
            <a:ahLst/>
            <a:rect l="l" t="t" r="r" b="b"/>
            <a:pathLst>
              <a:path w="303" h="123">
                <a:moveTo>
                  <a:pt x="0" y="0"/>
                </a:moveTo>
                <a:lnTo>
                  <a:pt x="0" y="123"/>
                </a:lnTo>
                <a:lnTo>
                  <a:pt x="303" y="12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3822840" y="5361120"/>
            <a:ext cx="147600" cy="266400"/>
          </a:xfrm>
          <a:custGeom>
            <a:avLst/>
            <a:gdLst/>
            <a:ahLst/>
            <a:rect l="l" t="t" r="r" b="b"/>
            <a:pathLst>
              <a:path w="93" h="168">
                <a:moveTo>
                  <a:pt x="0" y="168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4273920" y="5711760"/>
            <a:ext cx="45324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96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909960" y="5789520"/>
            <a:ext cx="360360" cy="109800"/>
          </a:xfrm>
          <a:custGeom>
            <a:avLst/>
            <a:gdLst/>
            <a:ahLst/>
            <a:rect l="l" t="t" r="r" b="b"/>
            <a:pathLst>
              <a:path w="227" h="69">
                <a:moveTo>
                  <a:pt x="0" y="69"/>
                </a:moveTo>
                <a:lnTo>
                  <a:pt x="0" y="0"/>
                </a:lnTo>
                <a:lnTo>
                  <a:pt x="22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287960" y="59403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810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909960" y="5908680"/>
            <a:ext cx="374760" cy="109440"/>
          </a:xfrm>
          <a:custGeom>
            <a:avLst/>
            <a:gdLst/>
            <a:ahLst/>
            <a:rect l="l" t="t" r="r" b="b"/>
            <a:pathLst>
              <a:path w="236" h="69">
                <a:moveTo>
                  <a:pt x="0" y="0"/>
                </a:moveTo>
                <a:lnTo>
                  <a:pt x="0" y="69"/>
                </a:lnTo>
                <a:lnTo>
                  <a:pt x="236" y="69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822840" y="5637240"/>
            <a:ext cx="87120" cy="266760"/>
          </a:xfrm>
          <a:custGeom>
            <a:avLst/>
            <a:gdLst/>
            <a:ahLst/>
            <a:rect l="l" t="t" r="r" b="b"/>
            <a:pathLst>
              <a:path w="55" h="168">
                <a:moveTo>
                  <a:pt x="0" y="0"/>
                </a:moveTo>
                <a:lnTo>
                  <a:pt x="0" y="168"/>
                </a:lnTo>
                <a:lnTo>
                  <a:pt x="55" y="168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605040" y="5632560"/>
            <a:ext cx="217800" cy="301680"/>
          </a:xfrm>
          <a:custGeom>
            <a:avLst/>
            <a:gdLst/>
            <a:ahLst/>
            <a:rect l="l" t="t" r="r" b="b"/>
            <a:pathLst>
              <a:path w="137" h="190">
                <a:moveTo>
                  <a:pt x="0" y="190"/>
                </a:moveTo>
                <a:lnTo>
                  <a:pt x="0" y="0"/>
                </a:lnTo>
                <a:lnTo>
                  <a:pt x="137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933000" y="6168960"/>
            <a:ext cx="47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CC30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605040" y="5943600"/>
            <a:ext cx="324000" cy="303120"/>
          </a:xfrm>
          <a:custGeom>
            <a:avLst/>
            <a:gdLst/>
            <a:ahLst/>
            <a:rect l="l" t="t" r="r" b="b"/>
            <a:pathLst>
              <a:path w="204" h="191">
                <a:moveTo>
                  <a:pt x="0" y="0"/>
                </a:moveTo>
                <a:lnTo>
                  <a:pt x="0" y="191"/>
                </a:lnTo>
                <a:lnTo>
                  <a:pt x="204" y="191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298680" y="5938920"/>
            <a:ext cx="306360" cy="261720"/>
          </a:xfrm>
          <a:custGeom>
            <a:avLst/>
            <a:gdLst/>
            <a:ahLst/>
            <a:rect l="l" t="t" r="r" b="b"/>
            <a:pathLst>
              <a:path w="193" h="165">
                <a:moveTo>
                  <a:pt x="0" y="165"/>
                </a:moveTo>
                <a:lnTo>
                  <a:pt x="0" y="0"/>
                </a:lnTo>
                <a:lnTo>
                  <a:pt x="193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549960" y="63975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298680" y="6210360"/>
            <a:ext cx="247680" cy="264960"/>
          </a:xfrm>
          <a:custGeom>
            <a:avLst/>
            <a:gdLst/>
            <a:ahLst/>
            <a:rect l="l" t="t" r="r" b="b"/>
            <a:pathLst>
              <a:path w="156" h="167">
                <a:moveTo>
                  <a:pt x="0" y="0"/>
                </a:moveTo>
                <a:lnTo>
                  <a:pt x="0" y="167"/>
                </a:lnTo>
                <a:lnTo>
                  <a:pt x="156" y="167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257640" y="6205680"/>
            <a:ext cx="41040" cy="242640"/>
          </a:xfrm>
          <a:custGeom>
            <a:avLst/>
            <a:gdLst/>
            <a:ahLst/>
            <a:rect l="l" t="t" r="r" b="b"/>
            <a:pathLst>
              <a:path w="26" h="153">
                <a:moveTo>
                  <a:pt x="0" y="153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942000" y="6626160"/>
            <a:ext cx="479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H780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257640" y="6458040"/>
            <a:ext cx="681120" cy="245880"/>
          </a:xfrm>
          <a:custGeom>
            <a:avLst/>
            <a:gdLst/>
            <a:ahLst/>
            <a:rect l="l" t="t" r="r" b="b"/>
            <a:pathLst>
              <a:path w="429" h="155">
                <a:moveTo>
                  <a:pt x="0" y="0"/>
                </a:moveTo>
                <a:lnTo>
                  <a:pt x="0" y="155"/>
                </a:lnTo>
                <a:lnTo>
                  <a:pt x="429" y="155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704960" y="5099040"/>
            <a:ext cx="1552680" cy="1354320"/>
          </a:xfrm>
          <a:custGeom>
            <a:avLst/>
            <a:gdLst/>
            <a:ahLst/>
            <a:rect l="l" t="t" r="r" b="b"/>
            <a:pathLst>
              <a:path w="978" h="853">
                <a:moveTo>
                  <a:pt x="0" y="0"/>
                </a:moveTo>
                <a:lnTo>
                  <a:pt x="0" y="853"/>
                </a:lnTo>
                <a:lnTo>
                  <a:pt x="978" y="853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679560" y="20955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8/99/7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3511440" y="226692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6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3366360" y="249228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18/75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509640" y="318924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64/58/5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334680" y="274464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37/53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2965320" y="304632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63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2952000" y="4562640"/>
            <a:ext cx="320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30/67/-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150720" y="36939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80/93/6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039480" y="3879720"/>
            <a:ext cx="2980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2/42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785680" y="430848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7/41/8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870360" y="484488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77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639600" y="502920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0/60/6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561840" y="522612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62/73/38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646080" y="60213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98/22/6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411000" y="548784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2/66/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182400" y="580716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4/73/7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889000" y="6066000"/>
            <a:ext cx="3693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49/77/76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762280" y="6481800"/>
            <a:ext cx="47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MS Sans Serif"/>
              </a:rPr>
              <a:t>54/100/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181240" y="7024680"/>
            <a:ext cx="284040" cy="144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181240" y="6986520"/>
            <a:ext cx="1440" cy="7632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465280" y="6986520"/>
            <a:ext cx="1800" cy="76320"/>
          </a:xfrm>
          <a:prstGeom prst="line">
            <a:avLst/>
          </a:prstGeom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250720" y="7062840"/>
            <a:ext cx="144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MS Sans Serif"/>
              </a:rPr>
              <a:t>0.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906360" y="8604360"/>
            <a:ext cx="277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Six et al., additional data file 5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126040" y="1995480"/>
            <a:ext cx="69840" cy="1522440"/>
          </a:xfrm>
          <a:custGeom>
            <a:avLst/>
            <a:gdLst/>
            <a:ahLst/>
            <a:rect l="l" t="t" r="r" b="b"/>
            <a:pathLst>
              <a:path w="30" h="1004">
                <a:moveTo>
                  <a:pt x="0" y="0"/>
                </a:moveTo>
                <a:lnTo>
                  <a:pt x="30" y="0"/>
                </a:lnTo>
                <a:lnTo>
                  <a:pt x="30" y="1004"/>
                </a:lnTo>
                <a:lnTo>
                  <a:pt x="0" y="100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5285160" y="2665440"/>
            <a:ext cx="303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Rp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124600" y="3597120"/>
            <a:ext cx="69840" cy="1090800"/>
          </a:xfrm>
          <a:custGeom>
            <a:avLst/>
            <a:gdLst/>
            <a:ahLst/>
            <a:rect l="l" t="t" r="r" b="b"/>
            <a:pathLst>
              <a:path w="30" h="1004">
                <a:moveTo>
                  <a:pt x="0" y="0"/>
                </a:moveTo>
                <a:lnTo>
                  <a:pt x="30" y="0"/>
                </a:lnTo>
                <a:lnTo>
                  <a:pt x="30" y="1004"/>
                </a:lnTo>
                <a:lnTo>
                  <a:pt x="0" y="100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5294520" y="4002120"/>
            <a:ext cx="300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Cpc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5127480" y="4788000"/>
            <a:ext cx="69840" cy="2016000"/>
          </a:xfrm>
          <a:custGeom>
            <a:avLst/>
            <a:gdLst/>
            <a:ahLst/>
            <a:rect l="l" t="t" r="r" b="b"/>
            <a:pathLst>
              <a:path w="30" h="1004">
                <a:moveTo>
                  <a:pt x="0" y="0"/>
                </a:moveTo>
                <a:lnTo>
                  <a:pt x="30" y="0"/>
                </a:lnTo>
                <a:lnTo>
                  <a:pt x="30" y="1004"/>
                </a:lnTo>
                <a:lnTo>
                  <a:pt x="0" y="1004"/>
                </a:lnTo>
              </a:path>
            </a:pathLst>
          </a:custGeom>
          <a:noFill/>
          <a:ln cap="sq"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5289840" y="5667480"/>
            <a:ext cx="309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MS Sans Serif"/>
              </a:rPr>
              <a:t>Cp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449600" y="3857760"/>
            <a:ext cx="141480" cy="141120"/>
          </a:xfrm>
          <a:prstGeom prst="star5">
            <a:avLst/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176720" y="3400560"/>
            <a:ext cx="142920" cy="14112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581360" y="4086360"/>
            <a:ext cx="141480" cy="14112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416480" y="4546440"/>
            <a:ext cx="142920" cy="140040"/>
          </a:xfrm>
          <a:prstGeom prst="star5">
            <a:avLst/>
          </a:prstGeom>
          <a:solidFill>
            <a:srgbClr val="00cc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653000" y="2038320"/>
            <a:ext cx="141120" cy="14148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656240" y="2268360"/>
            <a:ext cx="141120" cy="14148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" bIns="7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149720" y="4311720"/>
            <a:ext cx="142920" cy="139680"/>
          </a:xfrm>
          <a:prstGeom prst="star5">
            <a:avLst/>
          </a:prstGeom>
          <a:solidFill>
            <a:srgbClr val="00cc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0" bIns="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8" name=""/>
          <p:cNvGrpSpPr/>
          <p:nvPr/>
        </p:nvGrpSpPr>
        <p:grpSpPr>
          <a:xfrm>
            <a:off x="4521240" y="2719440"/>
            <a:ext cx="144360" cy="142920"/>
            <a:chOff x="4521240" y="2719440"/>
            <a:chExt cx="144360" cy="142920"/>
          </a:xfrm>
        </p:grpSpPr>
        <p:sp>
          <p:nvSpPr>
            <p:cNvPr id="139" name=""/>
            <p:cNvSpPr/>
            <p:nvPr/>
          </p:nvSpPr>
          <p:spPr>
            <a:xfrm>
              <a:off x="4521240" y="271944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4593960" y="271944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9380000">
              <a:off x="4608720" y="27529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rot="5400000">
              <a:off x="4615560" y="27655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9763200">
              <a:off x="4599360" y="28162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611240" y="27709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4621320" y="27709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4593960" y="27194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621320" y="28026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593960" y="282312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4621320" y="28036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4596120" y="282420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1" name=""/>
          <p:cNvGrpSpPr/>
          <p:nvPr/>
        </p:nvGrpSpPr>
        <p:grpSpPr>
          <a:xfrm>
            <a:off x="4710240" y="2948040"/>
            <a:ext cx="144360" cy="142920"/>
            <a:chOff x="4710240" y="2948040"/>
            <a:chExt cx="144360" cy="142920"/>
          </a:xfrm>
        </p:grpSpPr>
        <p:sp>
          <p:nvSpPr>
            <p:cNvPr id="152" name=""/>
            <p:cNvSpPr/>
            <p:nvPr/>
          </p:nvSpPr>
          <p:spPr>
            <a:xfrm>
              <a:off x="4710240" y="294804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782960" y="294804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rot="19380000">
              <a:off x="4797720" y="29815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rot="5400000">
              <a:off x="4804560" y="29941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rot="9763200">
              <a:off x="4788360" y="30448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800240" y="29995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4810320" y="29995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4782960" y="29480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4810320" y="30312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4782960" y="305172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4810320" y="30322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785120" y="305280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4" name=""/>
          <p:cNvGrpSpPr/>
          <p:nvPr/>
        </p:nvGrpSpPr>
        <p:grpSpPr>
          <a:xfrm>
            <a:off x="4869000" y="3170160"/>
            <a:ext cx="144360" cy="142920"/>
            <a:chOff x="4869000" y="3170160"/>
            <a:chExt cx="144360" cy="142920"/>
          </a:xfrm>
        </p:grpSpPr>
        <p:sp>
          <p:nvSpPr>
            <p:cNvPr id="165" name=""/>
            <p:cNvSpPr/>
            <p:nvPr/>
          </p:nvSpPr>
          <p:spPr>
            <a:xfrm>
              <a:off x="4869000" y="317016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941720" y="317016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rot="19380000">
              <a:off x="4956480" y="320364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rot="5400000">
              <a:off x="4963320" y="321624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rot="9763200">
              <a:off x="4947120" y="326700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959000" y="322164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4969080" y="322164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941720" y="317016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4969080" y="32533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941720" y="327384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4969080" y="32544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4943880" y="327492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7" name=""/>
          <p:cNvGrpSpPr/>
          <p:nvPr/>
        </p:nvGrpSpPr>
        <p:grpSpPr>
          <a:xfrm>
            <a:off x="4610160" y="2487600"/>
            <a:ext cx="144360" cy="142920"/>
            <a:chOff x="4610160" y="2487600"/>
            <a:chExt cx="144360" cy="142920"/>
          </a:xfrm>
        </p:grpSpPr>
        <p:sp>
          <p:nvSpPr>
            <p:cNvPr id="178" name=""/>
            <p:cNvSpPr/>
            <p:nvPr/>
          </p:nvSpPr>
          <p:spPr>
            <a:xfrm>
              <a:off x="4610160" y="248760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4682880" y="248760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9380000">
              <a:off x="4697640" y="252108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rot="5400000">
              <a:off x="4704480" y="253368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rot="9763200">
              <a:off x="4688280" y="258444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700160" y="253908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4710240" y="253908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682880" y="248760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710240" y="25707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682880" y="259128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710240" y="25718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685040" y="259236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0" name=""/>
          <p:cNvSpPr/>
          <p:nvPr/>
        </p:nvSpPr>
        <p:spPr>
          <a:xfrm>
            <a:off x="4451400" y="6600960"/>
            <a:ext cx="141120" cy="141120"/>
          </a:xfrm>
          <a:prstGeom prst="star5">
            <a:avLst/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4057560" y="6372360"/>
            <a:ext cx="142920" cy="141120"/>
          </a:xfrm>
          <a:prstGeom prst="star5">
            <a:avLst/>
          </a:prstGeom>
          <a:solidFill>
            <a:srgbClr val="ff505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437000" y="6143760"/>
            <a:ext cx="141480" cy="141120"/>
          </a:xfrm>
          <a:prstGeom prst="star5">
            <a:avLst/>
          </a:prstGeom>
          <a:solidFill>
            <a:srgbClr val="ff99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765680" y="5686560"/>
            <a:ext cx="14112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809960" y="5915160"/>
            <a:ext cx="141480" cy="141120"/>
          </a:xfrm>
          <a:prstGeom prst="star5">
            <a:avLst/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" bIns="3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5" name=""/>
          <p:cNvGrpSpPr/>
          <p:nvPr/>
        </p:nvGrpSpPr>
        <p:grpSpPr>
          <a:xfrm>
            <a:off x="4397400" y="3635280"/>
            <a:ext cx="144360" cy="142920"/>
            <a:chOff x="4397400" y="3635280"/>
            <a:chExt cx="144360" cy="142920"/>
          </a:xfrm>
        </p:grpSpPr>
        <p:sp>
          <p:nvSpPr>
            <p:cNvPr id="196" name=""/>
            <p:cNvSpPr/>
            <p:nvPr/>
          </p:nvSpPr>
          <p:spPr>
            <a:xfrm>
              <a:off x="4397400" y="363528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4470120" y="363528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rot="19380000">
              <a:off x="4484880" y="366876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 rot="5400000">
              <a:off x="4491720" y="368136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rot="9763200">
              <a:off x="4475520" y="373212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4487400" y="368676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4497480" y="368676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4470120" y="363528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4497480" y="371844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4470120" y="373896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4497480" y="371952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4472280" y="374004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8" name=""/>
          <p:cNvGrpSpPr/>
          <p:nvPr/>
        </p:nvGrpSpPr>
        <p:grpSpPr>
          <a:xfrm>
            <a:off x="4897440" y="4776840"/>
            <a:ext cx="144360" cy="142920"/>
            <a:chOff x="4897440" y="4776840"/>
            <a:chExt cx="144360" cy="142920"/>
          </a:xfrm>
        </p:grpSpPr>
        <p:sp>
          <p:nvSpPr>
            <p:cNvPr id="209" name=""/>
            <p:cNvSpPr/>
            <p:nvPr/>
          </p:nvSpPr>
          <p:spPr>
            <a:xfrm>
              <a:off x="4897440" y="477684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4970160" y="477684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rot="19380000">
              <a:off x="4984920" y="481032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rot="5400000">
              <a:off x="4991760" y="482292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rot="9763200">
              <a:off x="4975560" y="487368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4987440" y="482832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4997520" y="482832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970160" y="477684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4997520" y="486000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970160" y="488052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997520" y="48610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972320" y="488160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1" name=""/>
          <p:cNvGrpSpPr/>
          <p:nvPr/>
        </p:nvGrpSpPr>
        <p:grpSpPr>
          <a:xfrm>
            <a:off x="4856040" y="5010120"/>
            <a:ext cx="144720" cy="142920"/>
            <a:chOff x="4856040" y="5010120"/>
            <a:chExt cx="144720" cy="142920"/>
          </a:xfrm>
        </p:grpSpPr>
        <p:sp>
          <p:nvSpPr>
            <p:cNvPr id="222" name=""/>
            <p:cNvSpPr/>
            <p:nvPr/>
          </p:nvSpPr>
          <p:spPr>
            <a:xfrm>
              <a:off x="4856040" y="5010120"/>
              <a:ext cx="14472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929120" y="501012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rot="19380000">
              <a:off x="4943880" y="504360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rot="5400000">
              <a:off x="4950720" y="5055840"/>
              <a:ext cx="37800" cy="547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8800" bIns="-2880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rot="9763200">
              <a:off x="4934520" y="510696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4946040" y="506160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4956120" y="506160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4929120" y="501012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4956120" y="50932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4929120" y="511380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956120" y="50943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931280" y="5114880"/>
              <a:ext cx="4104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4" name=""/>
          <p:cNvGrpSpPr/>
          <p:nvPr/>
        </p:nvGrpSpPr>
        <p:grpSpPr>
          <a:xfrm>
            <a:off x="4803840" y="5238720"/>
            <a:ext cx="144360" cy="142920"/>
            <a:chOff x="4803840" y="5238720"/>
            <a:chExt cx="144360" cy="142920"/>
          </a:xfrm>
        </p:grpSpPr>
        <p:sp>
          <p:nvSpPr>
            <p:cNvPr id="235" name=""/>
            <p:cNvSpPr/>
            <p:nvPr/>
          </p:nvSpPr>
          <p:spPr>
            <a:xfrm>
              <a:off x="4803840" y="523872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876560" y="523872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rot="19380000">
              <a:off x="4891320" y="527220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rot="5400000">
              <a:off x="4898160" y="528480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rot="9763200">
              <a:off x="4881960" y="533556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4893840" y="529020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4903920" y="529020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4876560" y="523872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4903920" y="53218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4876560" y="534240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4903920" y="53229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4878720" y="534348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7" name=""/>
          <p:cNvGrpSpPr/>
          <p:nvPr/>
        </p:nvGrpSpPr>
        <p:grpSpPr>
          <a:xfrm>
            <a:off x="4916520" y="5467320"/>
            <a:ext cx="144360" cy="142920"/>
            <a:chOff x="4916520" y="5467320"/>
            <a:chExt cx="144360" cy="142920"/>
          </a:xfrm>
        </p:grpSpPr>
        <p:sp>
          <p:nvSpPr>
            <p:cNvPr id="248" name=""/>
            <p:cNvSpPr/>
            <p:nvPr/>
          </p:nvSpPr>
          <p:spPr>
            <a:xfrm>
              <a:off x="4916520" y="5467320"/>
              <a:ext cx="144360" cy="134640"/>
            </a:xfrm>
            <a:prstGeom prst="star5">
              <a:avLst/>
            </a:prstGeom>
            <a:solidFill>
              <a:srgbClr val="ff993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800" bIns="-1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4989240" y="5467320"/>
              <a:ext cx="32760" cy="10368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2960" bIns="-1296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rot="19380000">
              <a:off x="5004000" y="5500800"/>
              <a:ext cx="50040" cy="349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5280" bIns="-35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rot="5400000">
              <a:off x="5010840" y="5513400"/>
              <a:ext cx="37800" cy="5436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9160" bIns="-29160" anchor="t" anchorCtr="1" vert="eaVert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rot="9763200">
              <a:off x="4994640" y="5564160"/>
              <a:ext cx="31680" cy="42120"/>
            </a:xfrm>
            <a:prstGeom prst="rtTriangle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3120" bIns="-33120" anchor="ctr" rot="10800000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006520" y="5518800"/>
              <a:ext cx="54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5016600" y="5518800"/>
              <a:ext cx="4428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4989240" y="5467320"/>
              <a:ext cx="15480" cy="504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600" bIns="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5016600" y="555048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4989240" y="5571000"/>
              <a:ext cx="40680" cy="28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5016600" y="5551560"/>
              <a:ext cx="15840" cy="50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" bIns="3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4991400" y="5572080"/>
              <a:ext cx="40680" cy="29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280" bIns="-17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16T13:03:32Z</dcterms:created>
  <dc:creator>Laurence Garczarek</dc:creator>
  <dc:description/>
  <dc:language>en-US</dc:language>
  <cp:lastModifiedBy>Fred Partensky</cp:lastModifiedBy>
  <dcterms:modified xsi:type="dcterms:W3CDTF">2007-10-22T13:54:19Z</dcterms:modified>
  <cp:revision>29</cp:revision>
  <dc:subject/>
  <dc:title>Diapositive 1</dc:title>
</cp:coreProperties>
</file>